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15243-997B-4A6D-9C67-9CB71A0193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B3AE99-5A6E-40A4-9D5C-AD9250EFDE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F65F7F-4B7D-4868-9C16-D224DDD320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0352C7-F813-4173-AD02-959A6BB14A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ACE41-D510-49D3-BA58-C5DB4BAA7D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3488CB-1243-4EA3-8A51-21BD89D64F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6D569F-FD31-4F7A-B182-7EEDF459F5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BBD31E-51E7-4250-8801-E478E87434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46653-42E9-4FA4-A98E-739099AA04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74E15-1EC1-442C-A86F-638D2439A4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EFF31-DCDB-43D0-85E4-8ED5ED5284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CECA4C-4F12-4917-9506-09FB31BD8D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9B1508-91C8-4FEF-80D3-0B0A58C99E3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itle 1"/>
          <p:cNvSpPr/>
          <p:nvPr/>
        </p:nvSpPr>
        <p:spPr>
          <a:xfrm>
            <a:off x="609480" y="914400"/>
            <a:ext cx="8001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op network associated functions generated using  all up-regulated genes</a:t>
            </a:r>
            <a:br>
              <a:rPr sz="1200"/>
            </a:b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531800" y="1417680"/>
          <a:ext cx="6080400" cy="4022640"/>
        </p:xfrm>
        <a:graphic>
          <a:graphicData uri="http://schemas.openxmlformats.org/drawingml/2006/table">
            <a:tbl>
              <a:tblPr/>
              <a:tblGrid>
                <a:gridCol w="411480"/>
                <a:gridCol w="2514600"/>
                <a:gridCol w="514080"/>
                <a:gridCol w="2114640"/>
                <a:gridCol w="525600"/>
              </a:tblGrid>
              <a:tr h="36504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/w I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T474 associated network func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co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KBR3 associated network function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cor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4936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olecular Transport, Protein Trafficking, Cance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Embryonic Development, Organ Development, Organ Morpholog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40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Genetic Disorder, Skeletal and Muscular Disorders, Cellular Assembly and Organiz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otein Trafficking, Auditory and Vestibular System Development and Function, DNA Replication, Recombination, and Repair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440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ular Development, Hematological System Development and Function, Immune and Lymphatic System Development an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un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Molecular Transport, Hematological System Development and Function, Tissue Morpholog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188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Dermatological Diseases and Conditions, Cell-To-Cell Signaling and Interaction, Cellular Assembly and Organiza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ellular Development, Lipid Metabolism, Molecular Transpor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47560"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otein Degradation, Gene Expression, Protein Synthes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Lipid Metabolism, Molecular Transport, Small Molecule Biochemistry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t">
                      <a:noAutofit/>
                    </a:bodyPr>
                    <a:p>
                      <a:pPr algn="just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68760" marR="687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19T17:32:31Z</dcterms:created>
  <dc:creator>ykulkarni</dc:creator>
  <dc:description/>
  <dc:language>en-US</dc:language>
  <cp:lastModifiedBy>David Klinke</cp:lastModifiedBy>
  <dcterms:modified xsi:type="dcterms:W3CDTF">2010-06-11T21:33:31Z</dcterms:modified>
  <cp:revision>5</cp:revision>
  <dc:subject/>
  <dc:title>Slide 1</dc:title>
</cp:coreProperties>
</file>